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0" autoAdjust="0"/>
    <p:restoredTop sz="88073" autoAdjust="0"/>
  </p:normalViewPr>
  <p:slideViewPr>
    <p:cSldViewPr snapToGrid="0">
      <p:cViewPr varScale="1">
        <p:scale>
          <a:sx n="65" d="100"/>
          <a:sy n="65" d="100"/>
        </p:scale>
        <p:origin x="724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F272F2-CAE5-0975-3746-32E33D8262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3203BB-1D3B-5013-1EE7-7D06421E92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2" indent="0" algn="ctr">
              <a:buNone/>
              <a:defRPr sz="2000"/>
            </a:lvl2pPr>
            <a:lvl3pPr marL="914363" indent="0" algn="ctr">
              <a:buNone/>
              <a:defRPr sz="1800"/>
            </a:lvl3pPr>
            <a:lvl4pPr marL="1371545" indent="0" algn="ctr">
              <a:buNone/>
              <a:defRPr sz="1600"/>
            </a:lvl4pPr>
            <a:lvl5pPr marL="1828727" indent="0" algn="ctr">
              <a:buNone/>
              <a:defRPr sz="1600"/>
            </a:lvl5pPr>
            <a:lvl6pPr marL="2285909" indent="0" algn="ctr">
              <a:buNone/>
              <a:defRPr sz="1600"/>
            </a:lvl6pPr>
            <a:lvl7pPr marL="2743090" indent="0" algn="ctr">
              <a:buNone/>
              <a:defRPr sz="1600"/>
            </a:lvl7pPr>
            <a:lvl8pPr marL="3200272" indent="0" algn="ctr">
              <a:buNone/>
              <a:defRPr sz="1600"/>
            </a:lvl8pPr>
            <a:lvl9pPr marL="3657454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9F2FC5-8B4C-2733-905C-C4C662F0E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C764F5-BBC9-8382-32EC-04B5AC71C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DA313F-B094-04A3-E80D-07F3EB8D0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846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738360-1D68-47D3-F5C4-A8A509EAC5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BC29AA-CED3-8CC3-0B22-840439490E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4ECCF5-28C7-DF98-5910-F83338019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D342EB-6484-304C-D541-441DD3358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312101-906E-BA5F-7A6F-19B8B67B4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70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468525-8765-B0FF-CE95-39CC8F96A1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A3F9E2-D1F4-0ABB-691A-71C0BAAFF0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F3F9B5-B49C-C65C-1A4C-34462C469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21679F-61CB-28F4-6ECA-B98A2F3E2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23BC9F-7318-4F5D-5B5D-D9F9C9119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829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E50800-D92E-E515-6DE2-0FFC4E0B4E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8320C0-0CF7-AC79-1584-B02A26AD45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7DC333-6E9E-C33C-B823-04D6E3A52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FAF8B-D37E-C878-3891-7E561A6C2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A86906-D965-A43D-B903-696F0504F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612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B648CC-C40D-A1D7-B56D-B85EA01C7D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4FC507-E822-19F9-5CC0-1FAAC27055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9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7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A57A8-1F87-09D3-EF62-05E86A41A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B6081C-73C5-682E-8A65-86E7B7C83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392E10-5C9A-6F01-5A43-CD1EA163D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107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2A2A19-5D0E-E051-BBE0-0B799A71BD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9D417B-AD7B-8362-2685-A86CCEFD7B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1F2221-CEEE-F7C7-48D1-E3AFBDC175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9ABFB4-588E-E2D8-0DA0-16737CE34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C8009C-2720-4682-E610-CF111F28A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203DA4-CADD-F22B-8A4C-FBE26AA00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853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96D325-154A-A3D4-90B2-BCAECD9C3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756C4D-7B98-B81A-9102-EE60B73B66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0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2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600" b="1"/>
            </a:lvl4pPr>
            <a:lvl5pPr marL="1828727" indent="0">
              <a:buNone/>
              <a:defRPr sz="1600" b="1"/>
            </a:lvl5pPr>
            <a:lvl6pPr marL="2285909" indent="0">
              <a:buNone/>
              <a:defRPr sz="1600" b="1"/>
            </a:lvl6pPr>
            <a:lvl7pPr marL="2743090" indent="0">
              <a:buNone/>
              <a:defRPr sz="1600" b="1"/>
            </a:lvl7pPr>
            <a:lvl8pPr marL="3200272" indent="0">
              <a:buNone/>
              <a:defRPr sz="1600" b="1"/>
            </a:lvl8pPr>
            <a:lvl9pPr marL="365745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BE9969-7282-599D-44C7-F167784616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55C94B-179C-F1C4-4401-DF09086BCE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2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600" b="1"/>
            </a:lvl4pPr>
            <a:lvl5pPr marL="1828727" indent="0">
              <a:buNone/>
              <a:defRPr sz="1600" b="1"/>
            </a:lvl5pPr>
            <a:lvl6pPr marL="2285909" indent="0">
              <a:buNone/>
              <a:defRPr sz="1600" b="1"/>
            </a:lvl6pPr>
            <a:lvl7pPr marL="2743090" indent="0">
              <a:buNone/>
              <a:defRPr sz="1600" b="1"/>
            </a:lvl7pPr>
            <a:lvl8pPr marL="3200272" indent="0">
              <a:buNone/>
              <a:defRPr sz="1600" b="1"/>
            </a:lvl8pPr>
            <a:lvl9pPr marL="365745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6A6098-01DA-7A80-792B-91D9C44A01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ECB84AF-A675-AF4C-5A49-45917DB7F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A5EF88-C223-5417-5493-D942B48F9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DE086D9-D92C-9E1C-B3AB-5F8486038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379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71DFB-B415-9707-2A96-0A1F5FAD2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B1FE258-BC6D-FB03-4044-56BFFDA1E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D2413C6-4C55-BD69-9D20-EB0352C45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528E9B-2254-81AE-EE21-4F95B129C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757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7C67388-D3CC-C7CD-17AD-8977B4470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2D9950-8FC8-5356-217E-56E8BE51DD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551DDC7-3930-D37F-B19B-442FD2B26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636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D40AC7-7A2B-EAE4-9DEB-FBD6FBEEC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6F355C-7173-7D70-D067-82EBD289AD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06376E-1A17-C266-456A-CCF0E26296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2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7" indent="0">
              <a:buNone/>
              <a:defRPr sz="1000"/>
            </a:lvl5pPr>
            <a:lvl6pPr marL="2285909" indent="0">
              <a:buNone/>
              <a:defRPr sz="1000"/>
            </a:lvl6pPr>
            <a:lvl7pPr marL="2743090" indent="0">
              <a:buNone/>
              <a:defRPr sz="1000"/>
            </a:lvl7pPr>
            <a:lvl8pPr marL="3200272" indent="0">
              <a:buNone/>
              <a:defRPr sz="1000"/>
            </a:lvl8pPr>
            <a:lvl9pPr marL="3657454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99CC95-D746-D847-BBC5-7EA7B39BA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318B3A-3ADA-30A1-8123-E96A387BC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CC6B5A-81E1-EE82-188D-DFD5ECB0E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489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4D89B-24E4-295B-AA24-8B85EE9E4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E16CBA-C9D1-1890-B0D3-70C6B265C8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2" indent="0">
              <a:buNone/>
              <a:defRPr sz="2800"/>
            </a:lvl2pPr>
            <a:lvl3pPr marL="914363" indent="0">
              <a:buNone/>
              <a:defRPr sz="2400"/>
            </a:lvl3pPr>
            <a:lvl4pPr marL="1371545" indent="0">
              <a:buNone/>
              <a:defRPr sz="2000"/>
            </a:lvl4pPr>
            <a:lvl5pPr marL="1828727" indent="0">
              <a:buNone/>
              <a:defRPr sz="2000"/>
            </a:lvl5pPr>
            <a:lvl6pPr marL="2285909" indent="0">
              <a:buNone/>
              <a:defRPr sz="2000"/>
            </a:lvl6pPr>
            <a:lvl7pPr marL="2743090" indent="0">
              <a:buNone/>
              <a:defRPr sz="2000"/>
            </a:lvl7pPr>
            <a:lvl8pPr marL="3200272" indent="0">
              <a:buNone/>
              <a:defRPr sz="2000"/>
            </a:lvl8pPr>
            <a:lvl9pPr marL="3657454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64232C-0F99-938F-51FB-584AC32E67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2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7" indent="0">
              <a:buNone/>
              <a:defRPr sz="1000"/>
            </a:lvl5pPr>
            <a:lvl6pPr marL="2285909" indent="0">
              <a:buNone/>
              <a:defRPr sz="1000"/>
            </a:lvl6pPr>
            <a:lvl7pPr marL="2743090" indent="0">
              <a:buNone/>
              <a:defRPr sz="1000"/>
            </a:lvl7pPr>
            <a:lvl8pPr marL="3200272" indent="0">
              <a:buNone/>
              <a:defRPr sz="1000"/>
            </a:lvl8pPr>
            <a:lvl9pPr marL="3657454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7AF50B-CD77-0D51-3880-AD4C0CB33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460FB3-B5ED-31CA-8659-5B35BE77E2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6AD0B9-431A-FF7A-051D-5F165E54A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944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1EC7F8F-49CA-C2A1-AF8D-A7ED894D79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F0745D-B387-F698-5129-75EA7BE5C5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E1974F-8B0F-0E1C-4AF3-2103C251A9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93598-1FF4-49A7-B44C-F8D57BE15FEC}" type="datetimeFigureOut">
              <a:rPr lang="en-US" smtClean="0"/>
              <a:t>5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C9150-C624-F322-45A9-554FB59534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8974F2-4751-6694-9B59-2558F84BF8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4EA14-4ADE-4C5B-BF91-75B6FA8B9A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567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2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4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6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8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9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81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6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45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2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3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5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7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9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90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72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54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BD31E50-3BAF-7657-243D-AD5047ECF3EB}"/>
              </a:ext>
            </a:extLst>
          </p:cNvPr>
          <p:cNvSpPr txBox="1"/>
          <p:nvPr/>
        </p:nvSpPr>
        <p:spPr>
          <a:xfrm>
            <a:off x="1568245" y="237363"/>
            <a:ext cx="9257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igure S1: ICD codes used to define various dementia phenotypes from MVP electronic records </a:t>
            </a:r>
          </a:p>
        </p:txBody>
      </p:sp>
      <p:pic>
        <p:nvPicPr>
          <p:cNvPr id="4" name="Picture 3" descr="A close-up of a medical information&#10;&#10;AI-generated content may be incorrect.">
            <a:extLst>
              <a:ext uri="{FF2B5EF4-FFF2-40B4-BE49-F238E27FC236}">
                <a16:creationId xmlns:a16="http://schemas.microsoft.com/office/drawing/2014/main" id="{0725A2DD-8FAD-5C16-036B-D282ECFB9E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6852" y="936434"/>
            <a:ext cx="7984526" cy="49318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91DAE15-4281-0B18-5701-621B877BB837}"/>
              </a:ext>
            </a:extLst>
          </p:cNvPr>
          <p:cNvSpPr txBox="1"/>
          <p:nvPr/>
        </p:nvSpPr>
        <p:spPr>
          <a:xfrm flipH="1">
            <a:off x="2024548" y="5868303"/>
            <a:ext cx="82321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he MVP ADRD phenotype used in this paper include those from the AD and Related dementias rows. Two or more codes were required for an ADRD diagnosis</a:t>
            </a:r>
          </a:p>
        </p:txBody>
      </p:sp>
    </p:spTree>
    <p:extLst>
      <p:ext uri="{BB962C8B-B14F-4D97-AF65-F5344CB8AC3E}">
        <p14:creationId xmlns:p14="http://schemas.microsoft.com/office/powerpoint/2010/main" val="2695464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5AFD53C-98F2-97FD-A933-C947BEA7CC5D}"/>
              </a:ext>
            </a:extLst>
          </p:cNvPr>
          <p:cNvSpPr txBox="1"/>
          <p:nvPr/>
        </p:nvSpPr>
        <p:spPr>
          <a:xfrm rot="16200000">
            <a:off x="-1808860" y="246655"/>
            <a:ext cx="3976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nset &lt; 7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8BF9AAF-BFA7-0088-92D5-EEF26B23F151}"/>
              </a:ext>
            </a:extLst>
          </p:cNvPr>
          <p:cNvSpPr txBox="1"/>
          <p:nvPr/>
        </p:nvSpPr>
        <p:spPr>
          <a:xfrm rot="16200000">
            <a:off x="-1755317" y="3646884"/>
            <a:ext cx="3976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nset ≥75</a:t>
            </a:r>
          </a:p>
        </p:txBody>
      </p:sp>
      <p:pic>
        <p:nvPicPr>
          <p:cNvPr id="14" name="Picture 13" descr="A graph of blue and white bars&#10;&#10;AI-generated content may be incorrect.">
            <a:extLst>
              <a:ext uri="{FF2B5EF4-FFF2-40B4-BE49-F238E27FC236}">
                <a16:creationId xmlns:a16="http://schemas.microsoft.com/office/drawing/2014/main" id="{5CAD17BB-55C2-D36F-A883-7E9FD7A7B5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281" y="3351215"/>
            <a:ext cx="8917969" cy="3538331"/>
          </a:xfrm>
          <a:prstGeom prst="rect">
            <a:avLst/>
          </a:prstGeom>
        </p:spPr>
      </p:pic>
      <p:pic>
        <p:nvPicPr>
          <p:cNvPr id="8" name="Picture 7" descr="A graph with blue and red lines">
            <a:extLst>
              <a:ext uri="{FF2B5EF4-FFF2-40B4-BE49-F238E27FC236}">
                <a16:creationId xmlns:a16="http://schemas.microsoft.com/office/drawing/2014/main" id="{F7D4537D-C528-CDEF-98BA-FAEC4DB8726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281" y="381732"/>
            <a:ext cx="9052864" cy="312505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17915B3-A224-B87B-BA74-771C9127DD43}"/>
              </a:ext>
            </a:extLst>
          </p:cNvPr>
          <p:cNvSpPr txBox="1"/>
          <p:nvPr/>
        </p:nvSpPr>
        <p:spPr>
          <a:xfrm>
            <a:off x="2025445" y="108155"/>
            <a:ext cx="92572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igure S2: Manhattan and quantile-quantile plots from MVP/ADGC meta-analysis of onset age-stratified genome-wide association studies </a:t>
            </a:r>
          </a:p>
        </p:txBody>
      </p:sp>
      <p:pic>
        <p:nvPicPr>
          <p:cNvPr id="3" name="Picture 2" descr="A graph of a log-value&#10;&#10;AI-generated content may be incorrect.">
            <a:extLst>
              <a:ext uri="{FF2B5EF4-FFF2-40B4-BE49-F238E27FC236}">
                <a16:creationId xmlns:a16="http://schemas.microsoft.com/office/drawing/2014/main" id="{D6D04DA8-9664-D2ED-A1F5-E9DA9CF48A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89250" y="811616"/>
            <a:ext cx="2695169" cy="2695169"/>
          </a:xfrm>
          <a:prstGeom prst="rect">
            <a:avLst/>
          </a:prstGeom>
        </p:spPr>
      </p:pic>
      <p:pic>
        <p:nvPicPr>
          <p:cNvPr id="9" name="Picture 8" descr="A graph of a log-value&#10;&#10;AI-generated content may be incorrect.">
            <a:extLst>
              <a:ext uri="{FF2B5EF4-FFF2-40B4-BE49-F238E27FC236}">
                <a16:creationId xmlns:a16="http://schemas.microsoft.com/office/drawing/2014/main" id="{31315DE5-67BD-6770-F47C-0AC965AACFC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89250" y="4044477"/>
            <a:ext cx="2754346" cy="27543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13087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43E3B749-807E-A8E0-311A-7BB8B8FC25CA}"/>
              </a:ext>
            </a:extLst>
          </p:cNvPr>
          <p:cNvSpPr txBox="1"/>
          <p:nvPr/>
        </p:nvSpPr>
        <p:spPr>
          <a:xfrm rot="16200000">
            <a:off x="-1803722" y="436257"/>
            <a:ext cx="3976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emal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5F5F2AA-0539-3F5D-E1C9-F0ED89EA998D}"/>
              </a:ext>
            </a:extLst>
          </p:cNvPr>
          <p:cNvSpPr txBox="1"/>
          <p:nvPr/>
        </p:nvSpPr>
        <p:spPr>
          <a:xfrm rot="16200000">
            <a:off x="-1773784" y="3582267"/>
            <a:ext cx="3976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ales</a:t>
            </a:r>
          </a:p>
        </p:txBody>
      </p:sp>
      <p:pic>
        <p:nvPicPr>
          <p:cNvPr id="7" name="Picture 6" descr="A blue and red graph&#10;&#10;AI-generated content may be incorrect.">
            <a:extLst>
              <a:ext uri="{FF2B5EF4-FFF2-40B4-BE49-F238E27FC236}">
                <a16:creationId xmlns:a16="http://schemas.microsoft.com/office/drawing/2014/main" id="{45124BAC-70F5-DA9B-3E8A-31394D3AEB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209" y="3615838"/>
            <a:ext cx="8776437" cy="3242162"/>
          </a:xfrm>
          <a:prstGeom prst="rect">
            <a:avLst/>
          </a:prstGeom>
        </p:spPr>
      </p:pic>
      <p:pic>
        <p:nvPicPr>
          <p:cNvPr id="5" name="Picture 4" descr="A blue and white graph&#10;&#10;AI-generated content may be incorrect.">
            <a:extLst>
              <a:ext uri="{FF2B5EF4-FFF2-40B4-BE49-F238E27FC236}">
                <a16:creationId xmlns:a16="http://schemas.microsoft.com/office/drawing/2014/main" id="{E469DF29-9EB4-3FF6-77DA-97E93F109B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209" y="620922"/>
            <a:ext cx="8776436" cy="324216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DBA81F9-081C-CE3E-E8A9-E320C938E22E}"/>
              </a:ext>
            </a:extLst>
          </p:cNvPr>
          <p:cNvSpPr txBox="1"/>
          <p:nvPr/>
        </p:nvSpPr>
        <p:spPr>
          <a:xfrm>
            <a:off x="2025445" y="108155"/>
            <a:ext cx="92572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igure S3: Manhattan and quantile-quantile plots from MVP/ADGC meta-analysis of sex-stratified genome-wide association studies </a:t>
            </a:r>
          </a:p>
        </p:txBody>
      </p:sp>
      <p:pic>
        <p:nvPicPr>
          <p:cNvPr id="4" name="Picture 3" descr="A graph of a log-value&#10;&#10;AI-generated content may be incorrect.">
            <a:extLst>
              <a:ext uri="{FF2B5EF4-FFF2-40B4-BE49-F238E27FC236}">
                <a16:creationId xmlns:a16="http://schemas.microsoft.com/office/drawing/2014/main" id="{F3A51B39-8042-406B-9A6C-6A492D0053A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7490" y="868167"/>
            <a:ext cx="2994916" cy="2994916"/>
          </a:xfrm>
          <a:prstGeom prst="rect">
            <a:avLst/>
          </a:prstGeom>
        </p:spPr>
      </p:pic>
      <p:pic>
        <p:nvPicPr>
          <p:cNvPr id="10" name="Picture 9" descr="A graph of a log-value&#10;&#10;AI-generated content may be incorrect.">
            <a:extLst>
              <a:ext uri="{FF2B5EF4-FFF2-40B4-BE49-F238E27FC236}">
                <a16:creationId xmlns:a16="http://schemas.microsoft.com/office/drawing/2014/main" id="{B644F9E5-71D7-A631-8584-682F84A427D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4964" y="3766933"/>
            <a:ext cx="3108124" cy="3108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5931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5BC13CD-C175-FFE2-549D-1DFC582EE531}"/>
              </a:ext>
            </a:extLst>
          </p:cNvPr>
          <p:cNvSpPr txBox="1"/>
          <p:nvPr/>
        </p:nvSpPr>
        <p:spPr>
          <a:xfrm rot="16200000">
            <a:off x="-1825555" y="569821"/>
            <a:ext cx="3976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POE-ε4 Negativ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1DAFBB6-A5B7-832E-74B0-E320170833E2}"/>
              </a:ext>
            </a:extLst>
          </p:cNvPr>
          <p:cNvSpPr txBox="1"/>
          <p:nvPr/>
        </p:nvSpPr>
        <p:spPr>
          <a:xfrm rot="16200000">
            <a:off x="-1825555" y="4139810"/>
            <a:ext cx="3976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POE-ε4 Positive</a:t>
            </a:r>
          </a:p>
        </p:txBody>
      </p:sp>
      <p:pic>
        <p:nvPicPr>
          <p:cNvPr id="7" name="Picture 6" descr="A blue and red graph">
            <a:extLst>
              <a:ext uri="{FF2B5EF4-FFF2-40B4-BE49-F238E27FC236}">
                <a16:creationId xmlns:a16="http://schemas.microsoft.com/office/drawing/2014/main" id="{B99D31D3-495C-C78F-BCF0-217AD1BA56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500" y="3336533"/>
            <a:ext cx="8815227" cy="3521467"/>
          </a:xfrm>
          <a:prstGeom prst="rect">
            <a:avLst/>
          </a:prstGeom>
        </p:spPr>
      </p:pic>
      <p:pic>
        <p:nvPicPr>
          <p:cNvPr id="13" name="Picture 12" descr="A graph of blue and white bars">
            <a:extLst>
              <a:ext uri="{FF2B5EF4-FFF2-40B4-BE49-F238E27FC236}">
                <a16:creationId xmlns:a16="http://schemas.microsoft.com/office/drawing/2014/main" id="{1C8837B3-8B8B-A577-DCF6-987BBFBA00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500" y="620923"/>
            <a:ext cx="8737719" cy="292366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D52B2C3-51CA-9EB1-7FF8-2ADE41B02173}"/>
              </a:ext>
            </a:extLst>
          </p:cNvPr>
          <p:cNvSpPr txBox="1"/>
          <p:nvPr/>
        </p:nvSpPr>
        <p:spPr>
          <a:xfrm>
            <a:off x="2025445" y="108155"/>
            <a:ext cx="92572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igure S4: Manhattan and quantile-quantile plots from MVP/ADGC meta-analysis of </a:t>
            </a:r>
            <a:r>
              <a:rPr lang="en-US" i="1" dirty="0"/>
              <a:t>APOE</a:t>
            </a:r>
            <a:r>
              <a:rPr lang="en-US" dirty="0"/>
              <a:t>-stratified genome-wide association studies </a:t>
            </a:r>
          </a:p>
        </p:txBody>
      </p:sp>
      <p:pic>
        <p:nvPicPr>
          <p:cNvPr id="6" name="Picture 5" descr="A graph of a log-value&#10;&#10;AI-generated content may be incorrect.">
            <a:extLst>
              <a:ext uri="{FF2B5EF4-FFF2-40B4-BE49-F238E27FC236}">
                <a16:creationId xmlns:a16="http://schemas.microsoft.com/office/drawing/2014/main" id="{D1C14698-E169-002F-EC97-01876C41F8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85219" y="533446"/>
            <a:ext cx="3098616" cy="3098616"/>
          </a:xfrm>
          <a:prstGeom prst="rect">
            <a:avLst/>
          </a:prstGeom>
        </p:spPr>
      </p:pic>
      <p:pic>
        <p:nvPicPr>
          <p:cNvPr id="10" name="Picture 9" descr="A graph of a log-value&#10;&#10;AI-generated content may be incorrect.">
            <a:extLst>
              <a:ext uri="{FF2B5EF4-FFF2-40B4-BE49-F238E27FC236}">
                <a16:creationId xmlns:a16="http://schemas.microsoft.com/office/drawing/2014/main" id="{56827CAF-139B-AC17-5474-1573DBA0940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3973" y="3728737"/>
            <a:ext cx="3021108" cy="30211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0337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7571</TotalTime>
  <Words>107</Words>
  <Application>Microsoft Office PowerPoint</Application>
  <PresentationFormat>Widescreen</PresentationFormat>
  <Paragraphs>1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k Sherva</dc:creator>
  <cp:lastModifiedBy>Rick Sherva</cp:lastModifiedBy>
  <cp:revision>20</cp:revision>
  <dcterms:created xsi:type="dcterms:W3CDTF">2023-06-14T15:46:40Z</dcterms:created>
  <dcterms:modified xsi:type="dcterms:W3CDTF">2025-05-30T16:08:00Z</dcterms:modified>
</cp:coreProperties>
</file>